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87425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7" autoAdjust="0"/>
    <p:restoredTop sz="94608" autoAdjust="0"/>
  </p:normalViewPr>
  <p:slideViewPr>
    <p:cSldViewPr>
      <p:cViewPr varScale="1">
        <p:scale>
          <a:sx n="103" d="100"/>
          <a:sy n="103" d="100"/>
        </p:scale>
        <p:origin x="-27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FE698-4447-40B5-B9D5-145046A9441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9A687-5255-45FF-A6A4-8C2DBDFC3DED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684460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FE698-4447-40B5-B9D5-145046A9441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9A687-5255-45FF-A6A4-8C2DBDFC3DED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240453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FE698-4447-40B5-B9D5-145046A9441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9A687-5255-45FF-A6A4-8C2DBDFC3DED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21538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FE698-4447-40B5-B9D5-145046A9441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9A687-5255-45FF-A6A4-8C2DBDFC3DED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58681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FE698-4447-40B5-B9D5-145046A9441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9A687-5255-45FF-A6A4-8C2DBDFC3DED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56799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FE698-4447-40B5-B9D5-145046A9441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9A687-5255-45FF-A6A4-8C2DBDFC3DED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921585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FE698-4447-40B5-B9D5-145046A9441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9A687-5255-45FF-A6A4-8C2DBDFC3DED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74569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FE698-4447-40B5-B9D5-145046A9441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9A687-5255-45FF-A6A4-8C2DBDFC3DED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282239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FE698-4447-40B5-B9D5-145046A9441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9A687-5255-45FF-A6A4-8C2DBDFC3DED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203515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FE698-4447-40B5-B9D5-145046A9441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9A687-5255-45FF-A6A4-8C2DBDFC3DED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462620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FE698-4447-40B5-B9D5-145046A9441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9A687-5255-45FF-A6A4-8C2DBDFC3DED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935046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CFE698-4447-40B5-B9D5-145046A9441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E9A687-5255-45FF-A6A4-8C2DBDFC3DED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079000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9036496" cy="6266929"/>
            <a:chOff x="0" y="0"/>
            <a:chExt cx="9036496" cy="6266929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7624" y="1262328"/>
              <a:ext cx="2435990" cy="1944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79912" y="1262328"/>
              <a:ext cx="2431234" cy="1944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7624" y="3645024"/>
              <a:ext cx="2435990" cy="19442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79912" y="3645024"/>
              <a:ext cx="2431234" cy="19442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72201" y="3645024"/>
              <a:ext cx="2436952" cy="19442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233253" y="2096321"/>
              <a:ext cx="9242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oxia</a:t>
              </a:r>
              <a:endParaRPr lang="de-A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33253" y="4478631"/>
              <a:ext cx="9661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arvation</a:t>
              </a:r>
              <a:endParaRPr lang="de-A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979712" y="985329"/>
              <a:ext cx="66247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ntreated                                               CQ, 75µM                                            CQ, 150µM</a:t>
              </a:r>
              <a:endParaRPr lang="de-A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0" y="0"/>
              <a:ext cx="903649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dditional file 3: </a:t>
              </a:r>
              <a:r>
                <a:rPr lang="de-A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</a:t>
              </a:r>
              <a:r>
                <a:rPr lang="de-A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3</a:t>
              </a:r>
              <a:r>
                <a:rPr lang="de-A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Chloroquine (CQ) induces morphological changes of primary stromal cells and </a:t>
              </a:r>
              <a:r>
                <a:rPr lang="de-A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heir 		 detachment</a:t>
              </a:r>
              <a:r>
                <a:rPr lang="de-A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endParaRPr lang="de-A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33253" y="5805264"/>
              <a:ext cx="857589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Legend. </a:t>
              </a:r>
              <a:r>
                <a:rPr lang="de-A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imary stromal cells were cultured in starvation medium for 3 days, with CQ for the last 6 hs. Reprentative pictures of 3 independent experiments are shown.</a:t>
              </a:r>
              <a:endParaRPr lang="de-A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Picture 3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72200" y="1262328"/>
              <a:ext cx="2432183" cy="1944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2527151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imary stromal cells incubated with CQ _exp.1</dc:title>
  <dc:creator>Husak Zvenyslava</dc:creator>
  <cp:lastModifiedBy>Husak Zvenyslava</cp:lastModifiedBy>
  <cp:revision>12</cp:revision>
  <cp:lastPrinted>2016-09-20T09:46:37Z</cp:lastPrinted>
  <dcterms:created xsi:type="dcterms:W3CDTF">2016-09-19T14:04:21Z</dcterms:created>
  <dcterms:modified xsi:type="dcterms:W3CDTF">2016-10-19T11:54:30Z</dcterms:modified>
</cp:coreProperties>
</file>